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0138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646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75180"/>
            <a:ext cx="5829300" cy="313814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34345"/>
            <a:ext cx="5143500" cy="217625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7E64B-7C33-4FE8-B561-14BC2C79AE99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F447A-7430-4180-9082-9BC56B765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5953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7E64B-7C33-4FE8-B561-14BC2C79AE99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F447A-7430-4180-9082-9BC56B765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57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79903"/>
            <a:ext cx="1478756" cy="76388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79903"/>
            <a:ext cx="4350544" cy="76388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7E64B-7C33-4FE8-B561-14BC2C79AE99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F447A-7430-4180-9082-9BC56B765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09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7E64B-7C33-4FE8-B561-14BC2C79AE99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F447A-7430-4180-9082-9BC56B765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2511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47199"/>
            <a:ext cx="5915025" cy="374950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32171"/>
            <a:ext cx="5915025" cy="197177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7E64B-7C33-4FE8-B561-14BC2C79AE99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F447A-7430-4180-9082-9BC56B765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4356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99514"/>
            <a:ext cx="2914650" cy="5719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99514"/>
            <a:ext cx="2914650" cy="571918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7E64B-7C33-4FE8-B561-14BC2C79AE99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F447A-7430-4180-9082-9BC56B765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2211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905"/>
            <a:ext cx="5915025" cy="17422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09640"/>
            <a:ext cx="2901255" cy="108291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292550"/>
            <a:ext cx="2901255" cy="484284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09640"/>
            <a:ext cx="2915543" cy="108291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292550"/>
            <a:ext cx="2915543" cy="484284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7E64B-7C33-4FE8-B561-14BC2C79AE99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F447A-7430-4180-9082-9BC56B765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2269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7E64B-7C33-4FE8-B561-14BC2C79AE99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F447A-7430-4180-9082-9BC56B765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330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7E64B-7C33-4FE8-B561-14BC2C79AE99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F447A-7430-4180-9082-9BC56B765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8829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922"/>
            <a:ext cx="2211884" cy="210322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97826"/>
            <a:ext cx="3471863" cy="640565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4147"/>
            <a:ext cx="2211884" cy="500976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7E64B-7C33-4FE8-B561-14BC2C79AE99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F447A-7430-4180-9082-9BC56B765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6786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922"/>
            <a:ext cx="2211884" cy="210322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97826"/>
            <a:ext cx="3471863" cy="640565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4147"/>
            <a:ext cx="2211884" cy="500976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7E64B-7C33-4FE8-B561-14BC2C79AE99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0F447A-7430-4180-9082-9BC56B765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1930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79905"/>
            <a:ext cx="5915025" cy="17422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99514"/>
            <a:ext cx="5915025" cy="57191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354482"/>
            <a:ext cx="1543050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37E64B-7C33-4FE8-B561-14BC2C79AE99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354482"/>
            <a:ext cx="2314575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354482"/>
            <a:ext cx="1543050" cy="479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0F447A-7430-4180-9082-9BC56B76503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1035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754BFF44-9261-4FE4-BF4F-E73E39C43EC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7"/>
          <a:stretch/>
        </p:blipFill>
        <p:spPr>
          <a:xfrm>
            <a:off x="1143905" y="149864"/>
            <a:ext cx="4570189" cy="871409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A9D04C4E-7063-4B99-8B4E-F47DCEBFA646}"/>
              </a:ext>
            </a:extLst>
          </p:cNvPr>
          <p:cNvSpPr txBox="1"/>
          <p:nvPr/>
        </p:nvSpPr>
        <p:spPr>
          <a:xfrm rot="10800000">
            <a:off x="836128" y="3450994"/>
            <a:ext cx="307777" cy="169232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RAS Expression Level (log</a:t>
            </a:r>
            <a:r>
              <a:rPr lang="en-US" altLang="zh-CN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TPM)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23960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2AA5363-6B35-4A7A-838A-88E7C848A342}"/>
              </a:ext>
            </a:extLst>
          </p:cNvPr>
          <p:cNvSpPr txBox="1"/>
          <p:nvPr/>
        </p:nvSpPr>
        <p:spPr>
          <a:xfrm>
            <a:off x="340200" y="432455"/>
            <a:ext cx="6177600" cy="9871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5. The correlation between KRAS and immune cell infiltration (B cell, CD8+T cell, CD4+T cell, Macrophage, Neutrophil and Dendric Cell) in ACC, BLCA, CESC, CHOL, COAD, GBM, KICH, KIHC, KIRP, OV, PAAD, READ. </a:t>
            </a:r>
            <a:r>
              <a:rPr lang="en-US" sz="1000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Data was derived from the online dataset TIMER. The correlation thresholds </a:t>
            </a:r>
            <a:r>
              <a:rPr lang="en-US" sz="1000" i="0" u="none" strike="noStrike" baseline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∣R∣&gt;0.2 and p-value&lt;0.05 were considered </a:t>
            </a:r>
            <a:r>
              <a:rPr lang="en-US" altLang="zh-CN" sz="1000" i="0" u="none" strike="noStrike" baseline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 be </a:t>
            </a:r>
            <a:r>
              <a:rPr lang="en-US" sz="1000" i="0" u="none" strike="noStrike" baseline="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gnificantly correlations. </a:t>
            </a:r>
            <a:endParaRPr lang="en-US" sz="1000" kern="100" dirty="0">
              <a:solidFill>
                <a:srgbClr val="FF0000"/>
              </a:solidFill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3044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93</Words>
  <Application>Microsoft Office PowerPoint</Application>
  <PresentationFormat>Custom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i Shi</dc:creator>
  <cp:lastModifiedBy>MDPI</cp:lastModifiedBy>
  <cp:revision>7</cp:revision>
  <dcterms:created xsi:type="dcterms:W3CDTF">2021-10-06T01:49:17Z</dcterms:created>
  <dcterms:modified xsi:type="dcterms:W3CDTF">2022-04-22T11:53:28Z</dcterms:modified>
</cp:coreProperties>
</file>